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1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6"/>
  </p:notesMasterIdLst>
  <p:sldIdLst>
    <p:sldId id="256" r:id="rId3"/>
    <p:sldId id="258" r:id="rId4"/>
    <p:sldId id="257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g91w2k3\vol1\MANAGEMENT_SCIENCE\Projects\eHealth\QPATH4MS\AP03%20-%20Qualitaetsparameterdefinition\03%20QI%20-%20Bewertung\Expertenumfrage%20Runde%201\04%20Auswertung\QI%20einzeln_2022101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g91w2k3\vol1\MANAGEMENT_SCIENCE\Projects\eHealth\QPATH4MS\AP03%20-%20Qualitaetsparameterdefinition\03%20QI%20-%20Bewertung\Expertenumfrage%20Runde%201\04%20Auswertung\QI%20einzeln_2022101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g91w2k3\vol1\MANAGEMENT_SCIENCE\Projects\eHealth\QPATH4MS\AP03%20-%20Qualitaetsparameterdefinition\03%20QI%20-%20Bewertung\Expertenumfrage%20Runde%201\04%20Auswertung\QI%20einzeln_2022101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g91w2k3\vol1\ZKN-MANAGEMENT_SCIENCE\Projects\M&amp;S\QPATH4MS\AP03%20-%20Qualitaetsparameterdefinition\03%20QI%20-%20Bewertung\Expertenumfrage%20Runde%201\04%20Auswertung\QI%20einzeln_20221108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-Arbeitsblatt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g91w2k3\vol1\ZKN-MANAGEMENT_SCIENCE\Projects\M&amp;S\QPATH4MS\AP03%20-%20Qualitaetsparameterdefinition\03%20QI%20-%20Bewertung\Expertenumfrage%20Runde%202\04%20Auswertung\QI%20R2%20einzeln_2023012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g91w2k3\vol1\ZKN-MANAGEMENT_SCIENCE\Projects\M&amp;S\QPATH4MS\AP03%20-%20Qualitaetsparameterdefinition\03%20QI%20-%20Bewertung\Expertenumfrage%20Runde%202\04%20Auswertung\QI%20R2%20einzeln_20230125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package" Target="../embeddings/Microsoft_Excel-Arbeitsblat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000"/>
              <a:t>place of practice</a:t>
            </a:r>
          </a:p>
        </c:rich>
      </c:tx>
      <c:layout>
        <c:manualLayout>
          <c:xMode val="edge"/>
          <c:yMode val="edge"/>
          <c:x val="0.27730795506145456"/>
          <c:y val="4.23333333333333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49959390645286411"/>
          <c:y val="0.24586070637317867"/>
          <c:w val="0.45373230049469809"/>
          <c:h val="0.61163535522023693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32C-4722-8E86-DCA34E4D602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32C-4722-8E86-DCA34E4D602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32C-4722-8E86-DCA34E4D602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DS_2 Demografie'!$A$17:$A$19</c:f>
              <c:strCache>
                <c:ptCount val="3"/>
                <c:pt idx="0">
                  <c:v>city 
(&gt; 100.000 residents)</c:v>
                </c:pt>
                <c:pt idx="1">
                  <c:v>town, rural area    
(&lt;= 100.000 residents)</c:v>
                </c:pt>
                <c:pt idx="2">
                  <c:v>not specified</c:v>
                </c:pt>
              </c:strCache>
            </c:strRef>
          </c:cat>
          <c:val>
            <c:numRef>
              <c:f>'DS_2 Demografie'!$B$17:$B$19</c:f>
              <c:numCache>
                <c:formatCode>General</c:formatCode>
                <c:ptCount val="3"/>
                <c:pt idx="0">
                  <c:v>40</c:v>
                </c:pt>
                <c:pt idx="1">
                  <c:v>14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32C-4722-8E86-DCA34E4D602F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032C-4722-8E86-DCA34E4D602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032C-4722-8E86-DCA34E4D602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032C-4722-8E86-DCA34E4D602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DS_2 Demografie'!$A$17:$A$19</c:f>
              <c:strCache>
                <c:ptCount val="3"/>
                <c:pt idx="0">
                  <c:v>city 
(&gt; 100.000 residents)</c:v>
                </c:pt>
                <c:pt idx="1">
                  <c:v>town, rural area    
(&lt;= 100.000 residents)</c:v>
                </c:pt>
                <c:pt idx="2">
                  <c:v>not specified</c:v>
                </c:pt>
              </c:strCache>
            </c:strRef>
          </c:cat>
          <c:val>
            <c:numRef>
              <c:f>'DS_2 Demografie'!$C$17:$C$19</c:f>
              <c:numCache>
                <c:formatCode>0.0%</c:formatCode>
                <c:ptCount val="3"/>
                <c:pt idx="0">
                  <c:v>0.72727272727272729</c:v>
                </c:pt>
                <c:pt idx="1">
                  <c:v>0.25454545454545452</c:v>
                </c:pt>
                <c:pt idx="2">
                  <c:v>1.818181818181818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032C-4722-8E86-DCA34E4D602F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5.5013215790342691E-2"/>
          <c:y val="0.23911407601334206"/>
          <c:w val="0.38916346956748599"/>
          <c:h val="0.611532777777777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2000" b="0" i="0" u="none" strike="noStrike" kern="1200" spc="0" baseline="0" noProof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noProof="0" dirty="0"/>
              <a:t>type of practic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2000" b="0" i="0" u="none" strike="noStrike" kern="1200" spc="0" baseline="0" noProof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43045175357779009"/>
          <c:y val="0.25463486932742363"/>
          <c:w val="0.48025397702843808"/>
          <c:h val="0.57914682851242727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D62-4B67-9E9A-5E1702FC93D8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D62-4B67-9E9A-5E1702FC93D8}"/>
              </c:ext>
            </c:extLst>
          </c:dPt>
          <c:dPt>
            <c:idx val="2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D62-4B67-9E9A-5E1702FC93D8}"/>
              </c:ext>
            </c:extLst>
          </c:dPt>
          <c:dPt>
            <c:idx val="3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D62-4B67-9E9A-5E1702FC93D8}"/>
              </c:ext>
            </c:extLst>
          </c:dPt>
          <c:dPt>
            <c:idx val="4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D62-4B67-9E9A-5E1702FC93D8}"/>
              </c:ext>
            </c:extLst>
          </c:dPt>
          <c:dPt>
            <c:idx val="5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D62-4B67-9E9A-5E1702FC93D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('DS_2 Demografie'!$A$23:$A$24,'DS_2 Demografie'!$A$26:$A$29)</c:f>
              <c:strCache>
                <c:ptCount val="6"/>
                <c:pt idx="0">
                  <c:v>licensed - 
self-employed</c:v>
                </c:pt>
                <c:pt idx="1">
                  <c:v>licensed - 
medical care center</c:v>
                </c:pt>
                <c:pt idx="2">
                  <c:v>clinic - 
outpatient</c:v>
                </c:pt>
                <c:pt idx="3">
                  <c:v>clinic - 
inpatient</c:v>
                </c:pt>
                <c:pt idx="4">
                  <c:v>clinic - 
out- and inpatient</c:v>
                </c:pt>
                <c:pt idx="5">
                  <c:v>retirement</c:v>
                </c:pt>
              </c:strCache>
            </c:strRef>
          </c:cat>
          <c:val>
            <c:numRef>
              <c:f>('DS_2 Demografie'!$B$23:$B$24,'DS_2 Demografie'!$B$26:$B$29)</c:f>
              <c:numCache>
                <c:formatCode>General</c:formatCode>
                <c:ptCount val="6"/>
                <c:pt idx="0">
                  <c:v>10</c:v>
                </c:pt>
                <c:pt idx="1">
                  <c:v>1</c:v>
                </c:pt>
                <c:pt idx="2">
                  <c:v>15</c:v>
                </c:pt>
                <c:pt idx="3">
                  <c:v>21</c:v>
                </c:pt>
                <c:pt idx="4">
                  <c:v>6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D62-4B67-9E9A-5E1702FC93D8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AD62-4B67-9E9A-5E1702FC93D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AD62-4B67-9E9A-5E1702FC93D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AD62-4B67-9E9A-5E1702FC93D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AD62-4B67-9E9A-5E1702FC93D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AD62-4B67-9E9A-5E1702FC93D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AD62-4B67-9E9A-5E1702FC93D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('DS_2 Demografie'!$A$23:$A$24,'DS_2 Demografie'!$A$26:$A$29)</c:f>
              <c:strCache>
                <c:ptCount val="6"/>
                <c:pt idx="0">
                  <c:v>licensed - 
self-employed</c:v>
                </c:pt>
                <c:pt idx="1">
                  <c:v>licensed - 
medical care center</c:v>
                </c:pt>
                <c:pt idx="2">
                  <c:v>clinic - 
outpatient</c:v>
                </c:pt>
                <c:pt idx="3">
                  <c:v>clinic - 
inpatient</c:v>
                </c:pt>
                <c:pt idx="4">
                  <c:v>clinic - 
out- and inpatient</c:v>
                </c:pt>
                <c:pt idx="5">
                  <c:v>retirement</c:v>
                </c:pt>
              </c:strCache>
            </c:strRef>
          </c:cat>
          <c:val>
            <c:numRef>
              <c:f>('DS_2 Demografie'!$C$23:$C$24,'DS_2 Demografie'!$C$26:$C$29)</c:f>
              <c:numCache>
                <c:formatCode>0.0%</c:formatCode>
                <c:ptCount val="6"/>
                <c:pt idx="0">
                  <c:v>0.18181818181818182</c:v>
                </c:pt>
                <c:pt idx="1">
                  <c:v>1.8181818181818181E-2</c:v>
                </c:pt>
                <c:pt idx="2">
                  <c:v>0.27272727272727271</c:v>
                </c:pt>
                <c:pt idx="3">
                  <c:v>0.38181818181818183</c:v>
                </c:pt>
                <c:pt idx="4">
                  <c:v>0.10909090909090909</c:v>
                </c:pt>
                <c:pt idx="5">
                  <c:v>3.636363636363636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AD62-4B67-9E9A-5E1702FC93D8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"/>
          <c:y val="0.17496955763014668"/>
          <c:w val="0.50823371262469685"/>
          <c:h val="0.79781748206788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0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/>
              <a:t>means (years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('DS_2 Demografie'!$A$4,'DS_2 Demografie'!$A$8,'DS_2 Demografie'!$A$12)</c:f>
              <c:strCache>
                <c:ptCount val="3"/>
                <c:pt idx="0">
                  <c:v>age 
SD 11.5
range 29-73</c:v>
                </c:pt>
                <c:pt idx="1">
                  <c:v>duration of practice 
SD 11.0
range 2-47</c:v>
                </c:pt>
                <c:pt idx="2">
                  <c:v>specialized in MS
SD 9.6
range 0-37 </c:v>
                </c:pt>
              </c:strCache>
            </c:strRef>
          </c:cat>
          <c:val>
            <c:numRef>
              <c:f>('DS_2 Demografie'!$B$4,'DS_2 Demografie'!$B$8,'DS_2 Demografie'!$B$12)</c:f>
              <c:numCache>
                <c:formatCode>0.00</c:formatCode>
                <c:ptCount val="3"/>
                <c:pt idx="0" formatCode="General">
                  <c:v>52.7</c:v>
                </c:pt>
                <c:pt idx="1">
                  <c:v>24.6</c:v>
                </c:pt>
                <c:pt idx="2">
                  <c:v>19.1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39-4DC9-93D0-B212D85AE70A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588784056"/>
        <c:axId val="588783400"/>
      </c:barChart>
      <c:catAx>
        <c:axId val="588784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88783400"/>
        <c:crosses val="autoZero"/>
        <c:auto val="1"/>
        <c:lblAlgn val="ctr"/>
        <c:lblOffset val="100"/>
        <c:noMultiLvlLbl val="0"/>
      </c:catAx>
      <c:valAx>
        <c:axId val="588783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one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88784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000"/>
              <a:t>countr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259-42C0-9C72-BB188F4BDC6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259-42C0-9C72-BB188F4BDC68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259-42C0-9C72-BB188F4BDC6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('DS_2 Demografie'!$A$33,'DS_2 Demografie'!$A$36:$A$37)</c:f>
              <c:strCache>
                <c:ptCount val="3"/>
                <c:pt idx="0">
                  <c:v>Germany</c:v>
                </c:pt>
                <c:pt idx="1">
                  <c:v>Austria</c:v>
                </c:pt>
                <c:pt idx="2">
                  <c:v>Switzerland</c:v>
                </c:pt>
              </c:strCache>
            </c:strRef>
          </c:cat>
          <c:val>
            <c:numRef>
              <c:f>('DS_2 Demografie'!$B$33,'DS_2 Demografie'!$B$36:$B$37)</c:f>
              <c:numCache>
                <c:formatCode>General</c:formatCode>
                <c:ptCount val="3"/>
                <c:pt idx="0">
                  <c:v>48</c:v>
                </c:pt>
                <c:pt idx="1">
                  <c:v>2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259-42C0-9C72-BB188F4BDC68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E259-42C0-9C72-BB188F4BDC6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E259-42C0-9C72-BB188F4BDC6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E259-42C0-9C72-BB188F4BDC6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('DS_2 Demografie'!$A$33,'DS_2 Demografie'!$A$36:$A$37)</c:f>
              <c:strCache>
                <c:ptCount val="3"/>
                <c:pt idx="0">
                  <c:v>Germany</c:v>
                </c:pt>
                <c:pt idx="1">
                  <c:v>Austria</c:v>
                </c:pt>
                <c:pt idx="2">
                  <c:v>Switzerland</c:v>
                </c:pt>
              </c:strCache>
            </c:strRef>
          </c:cat>
          <c:val>
            <c:numRef>
              <c:f>('DS_2 Demografie'!$C$33,'DS_2 Demografie'!$C$36:$C$37)</c:f>
              <c:numCache>
                <c:formatCode>0.0%</c:formatCode>
                <c:ptCount val="3"/>
                <c:pt idx="0">
                  <c:v>0.87272727272727268</c:v>
                </c:pt>
                <c:pt idx="1">
                  <c:v>3.6363636363636362E-2</c:v>
                </c:pt>
                <c:pt idx="2">
                  <c:v>9.090909090909091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E259-42C0-9C72-BB188F4BDC68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000"/>
              <a:t>means (years)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('DS_2 Demografie'!$A$4,'DS_2 Demografie'!$A$8,'DS_2 Demografie'!$A$12)</c:f>
              <c:strCache>
                <c:ptCount val="3"/>
                <c:pt idx="0">
                  <c:v>age 
SD 10.7
range 29-73</c:v>
                </c:pt>
                <c:pt idx="1">
                  <c:v>duration of practice 
SD 11.2
range 3-52</c:v>
                </c:pt>
                <c:pt idx="2">
                  <c:v>specialized in MS
SD 9.4
range 1-37 </c:v>
                </c:pt>
              </c:strCache>
            </c:strRef>
          </c:cat>
          <c:val>
            <c:numRef>
              <c:f>('DS_2 Demografie'!$B$4,'DS_2 Demografie'!$B$8,'DS_2 Demografie'!$B$12)</c:f>
              <c:numCache>
                <c:formatCode>General</c:formatCode>
                <c:ptCount val="3"/>
                <c:pt idx="0">
                  <c:v>53.1</c:v>
                </c:pt>
                <c:pt idx="1">
                  <c:v>26.3</c:v>
                </c:pt>
                <c:pt idx="2" formatCode="0.00">
                  <c:v>19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A4-4956-A7D5-8B251ED1610C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588784056"/>
        <c:axId val="588783400"/>
      </c:barChart>
      <c:catAx>
        <c:axId val="588784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88783400"/>
        <c:crosses val="autoZero"/>
        <c:auto val="1"/>
        <c:lblAlgn val="ctr"/>
        <c:lblOffset val="100"/>
        <c:noMultiLvlLbl val="0"/>
      </c:catAx>
      <c:valAx>
        <c:axId val="588783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88784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000"/>
              <a:t>place of practic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4544111345722614"/>
          <c:y val="0.19651457776890702"/>
          <c:w val="0.42738322989765187"/>
          <c:h val="0.62036818473238653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4C2-4833-9219-810BD1E196E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4C2-4833-9219-810BD1E196E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4C2-4833-9219-810BD1E196E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DS_2 Demografie'!$A$17:$A$19</c:f>
              <c:strCache>
                <c:ptCount val="3"/>
                <c:pt idx="0">
                  <c:v>city 
(&gt; 100.000 residents)</c:v>
                </c:pt>
                <c:pt idx="1">
                  <c:v>town, rural area    
(&lt;= 100.000 residents)</c:v>
                </c:pt>
                <c:pt idx="2">
                  <c:v>not specified</c:v>
                </c:pt>
              </c:strCache>
            </c:strRef>
          </c:cat>
          <c:val>
            <c:numRef>
              <c:f>'DS_2 Demografie'!$B$17:$B$19</c:f>
              <c:numCache>
                <c:formatCode>General</c:formatCode>
                <c:ptCount val="3"/>
                <c:pt idx="0">
                  <c:v>39</c:v>
                </c:pt>
                <c:pt idx="1">
                  <c:v>12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4C2-4833-9219-810BD1E196E4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C4C2-4833-9219-810BD1E196E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C4C2-4833-9219-810BD1E196E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C4C2-4833-9219-810BD1E196E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DS_2 Demografie'!$A$17:$A$19</c:f>
              <c:strCache>
                <c:ptCount val="3"/>
                <c:pt idx="0">
                  <c:v>city 
(&gt; 100.000 residents)</c:v>
                </c:pt>
                <c:pt idx="1">
                  <c:v>town, rural area    
(&lt;= 100.000 residents)</c:v>
                </c:pt>
                <c:pt idx="2">
                  <c:v>not specified</c:v>
                </c:pt>
              </c:strCache>
            </c:strRef>
          </c:cat>
          <c:val>
            <c:numRef>
              <c:f>'DS_2 Demografie'!$C$17:$C$19</c:f>
              <c:numCache>
                <c:formatCode>0.0%</c:formatCode>
                <c:ptCount val="3"/>
                <c:pt idx="0">
                  <c:v>0.79591836734693877</c:v>
                </c:pt>
                <c:pt idx="1">
                  <c:v>0.24489795918367346</c:v>
                </c:pt>
                <c:pt idx="2">
                  <c:v>8.163265306122448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4C2-4833-9219-810BD1E196E4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2.641041103410904E-2"/>
          <c:y val="0.29993529829621302"/>
          <c:w val="0.45575064419503963"/>
          <c:h val="0.505699186459129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000"/>
              <a:t>type of practic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46997824054885839"/>
          <c:y val="0.20419108958155627"/>
          <c:w val="0.46247569423010787"/>
          <c:h val="0.6566667710102283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DE0-44EE-8767-BA95DFC813B0}"/>
              </c:ext>
            </c:extLst>
          </c:dPt>
          <c:dPt>
            <c:idx val="1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DE0-44EE-8767-BA95DFC813B0}"/>
              </c:ext>
            </c:extLst>
          </c:dPt>
          <c:dPt>
            <c:idx val="2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DE0-44EE-8767-BA95DFC813B0}"/>
              </c:ext>
            </c:extLst>
          </c:dPt>
          <c:dPt>
            <c:idx val="3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DE0-44EE-8767-BA95DFC813B0}"/>
              </c:ext>
            </c:extLst>
          </c:dPt>
          <c:dPt>
            <c:idx val="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DE0-44EE-8767-BA95DFC813B0}"/>
              </c:ext>
            </c:extLst>
          </c:dPt>
          <c:dPt>
            <c:idx val="5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DE0-44EE-8767-BA95DFC813B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('DS_2 Demografie'!$A$23:$A$24,'DS_2 Demografie'!$A$26:$A$29)</c:f>
              <c:strCache>
                <c:ptCount val="6"/>
                <c:pt idx="0">
                  <c:v>licensed - 
self-employed</c:v>
                </c:pt>
                <c:pt idx="1">
                  <c:v>licensed - 
medical care center</c:v>
                </c:pt>
                <c:pt idx="2">
                  <c:v>clinic - 
outpatient</c:v>
                </c:pt>
                <c:pt idx="3">
                  <c:v>clinic - 
inpatient</c:v>
                </c:pt>
                <c:pt idx="4">
                  <c:v>clinic - 
out- and inpatient</c:v>
                </c:pt>
                <c:pt idx="5">
                  <c:v>other</c:v>
                </c:pt>
              </c:strCache>
            </c:strRef>
          </c:cat>
          <c:val>
            <c:numRef>
              <c:f>('DS_2 Demografie'!$B$23:$B$24,'DS_2 Demografie'!$B$26:$B$29)</c:f>
              <c:numCache>
                <c:formatCode>General</c:formatCode>
                <c:ptCount val="6"/>
                <c:pt idx="0">
                  <c:v>9</c:v>
                </c:pt>
                <c:pt idx="1">
                  <c:v>1</c:v>
                </c:pt>
                <c:pt idx="2">
                  <c:v>15</c:v>
                </c:pt>
                <c:pt idx="3">
                  <c:v>20</c:v>
                </c:pt>
                <c:pt idx="4">
                  <c:v>4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DE0-44EE-8767-BA95DFC813B0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2DE0-44EE-8767-BA95DFC813B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2DE0-44EE-8767-BA95DFC813B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2DE0-44EE-8767-BA95DFC813B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2DE0-44EE-8767-BA95DFC813B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2DE0-44EE-8767-BA95DFC813B0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2DE0-44EE-8767-BA95DFC813B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('DS_2 Demografie'!$A$23:$A$24,'DS_2 Demografie'!$A$26:$A$29)</c:f>
              <c:strCache>
                <c:ptCount val="6"/>
                <c:pt idx="0">
                  <c:v>licensed - 
self-employed</c:v>
                </c:pt>
                <c:pt idx="1">
                  <c:v>licensed - 
medical care center</c:v>
                </c:pt>
                <c:pt idx="2">
                  <c:v>clinic - 
outpatient</c:v>
                </c:pt>
                <c:pt idx="3">
                  <c:v>clinic - 
inpatient</c:v>
                </c:pt>
                <c:pt idx="4">
                  <c:v>clinic - 
out- and inpatient</c:v>
                </c:pt>
                <c:pt idx="5">
                  <c:v>other</c:v>
                </c:pt>
              </c:strCache>
            </c:strRef>
          </c:cat>
          <c:val>
            <c:numRef>
              <c:f>('DS_2 Demografie'!$C$23:$C$24,'DS_2 Demografie'!$C$26:$C$29)</c:f>
              <c:numCache>
                <c:formatCode>0.0%</c:formatCode>
                <c:ptCount val="6"/>
                <c:pt idx="0">
                  <c:v>0.18367346938775511</c:v>
                </c:pt>
                <c:pt idx="1">
                  <c:v>2.0408163265306121E-2</c:v>
                </c:pt>
                <c:pt idx="2">
                  <c:v>0.30612244897959184</c:v>
                </c:pt>
                <c:pt idx="3">
                  <c:v>0.40816326530612246</c:v>
                </c:pt>
                <c:pt idx="4">
                  <c:v>8.1632653061224483E-2</c:v>
                </c:pt>
                <c:pt idx="5">
                  <c:v>4.08163265306122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2DE0-44EE-8767-BA95DFC813B0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2.0998862423830898E-2"/>
          <c:y val="0.17814341500825617"/>
          <c:w val="0.41993122734768384"/>
          <c:h val="0.773363436450858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2000"/>
              <a:t>countr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35607881870374425"/>
          <c:y val="0.23194519545296607"/>
          <c:w val="0.56931392564458949"/>
          <c:h val="0.68972147464035549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37B-4E52-B24D-44378D9DEFE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37B-4E52-B24D-44378D9DEFEA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37B-4E52-B24D-44378D9DEFE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('DS_2 Demografie'!$A$33,'DS_2 Demografie'!$A$36:$A$37)</c:f>
              <c:strCache>
                <c:ptCount val="3"/>
                <c:pt idx="0">
                  <c:v>Germany</c:v>
                </c:pt>
                <c:pt idx="1">
                  <c:v>Austria</c:v>
                </c:pt>
                <c:pt idx="2">
                  <c:v>Switzerland</c:v>
                </c:pt>
              </c:strCache>
            </c:strRef>
          </c:cat>
          <c:val>
            <c:numRef>
              <c:f>('DS_2 Demografie'!$B$33,'DS_2 Demografie'!$B$36:$B$37)</c:f>
              <c:numCache>
                <c:formatCode>General</c:formatCode>
                <c:ptCount val="3"/>
                <c:pt idx="0">
                  <c:v>47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37B-4E52-B24D-44378D9DEFEA}"/>
            </c:ext>
          </c:extLst>
        </c:ser>
        <c:ser>
          <c:idx val="1"/>
          <c:order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A37B-4E52-B24D-44378D9DEFE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A37B-4E52-B24D-44378D9DEFE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A37B-4E52-B24D-44378D9DEFE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('DS_2 Demografie'!$A$33,'DS_2 Demografie'!$A$36:$A$37)</c:f>
              <c:strCache>
                <c:ptCount val="3"/>
                <c:pt idx="0">
                  <c:v>Germany</c:v>
                </c:pt>
                <c:pt idx="1">
                  <c:v>Austria</c:v>
                </c:pt>
                <c:pt idx="2">
                  <c:v>Switzerland</c:v>
                </c:pt>
              </c:strCache>
            </c:strRef>
          </c:cat>
          <c:val>
            <c:numRef>
              <c:f>('DS_2 Demografie'!$C$33,'DS_2 Demografie'!$C$36:$C$37)</c:f>
              <c:numCache>
                <c:formatCode>0.0%</c:formatCode>
                <c:ptCount val="3"/>
                <c:pt idx="0">
                  <c:v>0.95918367346938771</c:v>
                </c:pt>
                <c:pt idx="1">
                  <c:v>2.0408163265306121E-2</c:v>
                </c:pt>
                <c:pt idx="2">
                  <c:v>2.040816326530612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A37B-4E52-B24D-44378D9DEFEA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EB3CFB-BA7E-478C-BC58-D05D953691C0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7379E0-0FA8-467E-AC05-423C977A6D9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3054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BD12400-F2B9-43FD-92CF-F1B7A9633199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700621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0635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546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904348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F6A61-777C-4544-9AF3-C2548C8498BE}" type="datetime1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397981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67178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0FAA6-262F-4A9D-9273-7E7AF1D53E37}" type="datetime1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220960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8509-F5F3-4875-BA4D-2793AD2ECCE9}" type="datetime1">
              <a:rPr lang="de-DE" smtClean="0"/>
              <a:t>16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884545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C1D21-D49B-43AD-9510-E570E7A3EBDF}" type="datetime1">
              <a:rPr lang="de-DE" smtClean="0"/>
              <a:t>16.08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292131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oliennummernplatzhalter 5"/>
          <p:cNvSpPr>
            <a:spLocks noGrp="1"/>
          </p:cNvSpPr>
          <p:nvPr>
            <p:ph type="sldNum" sz="quarter" idx="12"/>
          </p:nvPr>
        </p:nvSpPr>
        <p:spPr>
          <a:xfrm>
            <a:off x="9113108" y="6323399"/>
            <a:ext cx="2743200" cy="365125"/>
          </a:xfrm>
        </p:spPr>
        <p:txBody>
          <a:bodyPr/>
          <a:lstStyle>
            <a:lvl1pPr>
              <a:defRPr/>
            </a:lvl1pPr>
          </a:lstStyle>
          <a:p>
            <a:fld id="{DCDC1D6B-BDEA-4D57-A93D-F61244115E3B}" type="slidenum">
              <a:rPr lang="de-DE" smtClean="0"/>
              <a:pPr/>
              <a:t>‹Nr.›</a:t>
            </a:fld>
            <a:endParaRPr lang="de-DE" dirty="0"/>
          </a:p>
        </p:txBody>
      </p:sp>
      <p:pic>
        <p:nvPicPr>
          <p:cNvPr id="9" name="Grafik 8" descr="Ein Bild, das Text enthält.&#10;&#10;Automatisch generierte Beschreibung">
            <a:extLst>
              <a:ext uri="{FF2B5EF4-FFF2-40B4-BE49-F238E27FC236}">
                <a16:creationId xmlns:a16="http://schemas.microsoft.com/office/drawing/2014/main" id="{7D001BDD-2B84-E540-B5FE-4247DA3A241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0969874" y="3090956"/>
            <a:ext cx="1584589" cy="626661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9697485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EDB170-3867-401C-997D-C1AC34CADC69}" type="datetime1">
              <a:rPr lang="de-DE" smtClean="0"/>
              <a:t>16.08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629853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814E4-C43C-40A4-B069-BB647AEFCE31}" type="datetime1">
              <a:rPr lang="de-DE" smtClean="0"/>
              <a:t>16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3781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674314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263ED-4423-440E-BC4D-C0F7681E5EB4}" type="datetime1">
              <a:rPr lang="de-DE" smtClean="0"/>
              <a:t>16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9169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E343E-CD0B-4115-981D-0A95A31A65DD}" type="datetime1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161441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A757F-E0C2-48F7-8B95-97D87DEADE29}" type="datetime1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7990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1_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Rectangle 3"/>
          <p:cNvSpPr>
            <a:spLocks noGrp="1" noChangeArrowheads="1"/>
          </p:cNvSpPr>
          <p:nvPr>
            <p:ph type="ctrTitle" hasCustomPrompt="1"/>
          </p:nvPr>
        </p:nvSpPr>
        <p:spPr>
          <a:xfrm>
            <a:off x="912285" y="1835424"/>
            <a:ext cx="10752667" cy="777875"/>
          </a:xfrm>
        </p:spPr>
        <p:txBody>
          <a:bodyPr anchor="b" anchorCtr="0"/>
          <a:lstStyle>
            <a:lvl1pPr>
              <a:lnSpc>
                <a:spcPct val="100000"/>
              </a:lnSpc>
              <a:defRPr sz="3904" b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de-DE" noProof="0" dirty="0"/>
              <a:t>Titelmasterformat durch </a:t>
            </a:r>
            <a:br>
              <a:rPr lang="de-DE" noProof="0" dirty="0"/>
            </a:br>
            <a:r>
              <a:rPr lang="de-DE" noProof="0" dirty="0"/>
              <a:t>Klicken bearbeiten</a:t>
            </a:r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subTitle" idx="1" hasCustomPrompt="1"/>
          </p:nvPr>
        </p:nvSpPr>
        <p:spPr>
          <a:xfrm>
            <a:off x="912285" y="2730774"/>
            <a:ext cx="10752667" cy="673699"/>
          </a:xfrm>
        </p:spPr>
        <p:txBody>
          <a:bodyPr/>
          <a:lstStyle>
            <a:lvl1pPr marL="0" indent="0">
              <a:buFont typeface="Arial Black" pitchFamily="34" charset="0"/>
              <a:buNone/>
              <a:defRPr sz="1757" b="1">
                <a:solidFill>
                  <a:schemeClr val="tx1"/>
                </a:solidFill>
              </a:defRPr>
            </a:lvl1pPr>
          </a:lstStyle>
          <a:p>
            <a:pPr lvl="0"/>
            <a:r>
              <a:rPr lang="de-DE" noProof="0" dirty="0"/>
              <a:t>Formatvorlage des Untertitelmasters </a:t>
            </a:r>
            <a:br>
              <a:rPr lang="de-DE" noProof="0" dirty="0"/>
            </a:br>
            <a:r>
              <a:rPr lang="de-DE" noProof="0" dirty="0"/>
              <a:t>durch Klicken bearbeiten</a:t>
            </a:r>
          </a:p>
        </p:txBody>
      </p:sp>
      <p:sp>
        <p:nvSpPr>
          <p:cNvPr id="81" name="Bildplatzhalter 2"/>
          <p:cNvSpPr>
            <a:spLocks noGrp="1"/>
          </p:cNvSpPr>
          <p:nvPr>
            <p:ph type="pic" sz="quarter" idx="10"/>
          </p:nvPr>
        </p:nvSpPr>
        <p:spPr>
          <a:xfrm>
            <a:off x="0" y="3626397"/>
            <a:ext cx="4065167" cy="2898229"/>
          </a:xfrm>
          <a:solidFill>
            <a:schemeClr val="bg1">
              <a:lumMod val="85000"/>
            </a:schemeClr>
          </a:solidFill>
        </p:spPr>
        <p:txBody>
          <a:bodyPr/>
          <a:lstStyle/>
          <a:p>
            <a:endParaRPr lang="de-DE"/>
          </a:p>
        </p:txBody>
      </p:sp>
      <p:sp>
        <p:nvSpPr>
          <p:cNvPr id="82" name="Bildplatzhalter 2"/>
          <p:cNvSpPr>
            <a:spLocks noGrp="1"/>
          </p:cNvSpPr>
          <p:nvPr>
            <p:ph type="pic" sz="quarter" idx="11"/>
          </p:nvPr>
        </p:nvSpPr>
        <p:spPr>
          <a:xfrm>
            <a:off x="4058182" y="3626397"/>
            <a:ext cx="4065167" cy="2898229"/>
          </a:xfrm>
          <a:solidFill>
            <a:schemeClr val="bg1">
              <a:lumMod val="85000"/>
            </a:schemeClr>
          </a:solidFill>
        </p:spPr>
        <p:txBody>
          <a:bodyPr/>
          <a:lstStyle/>
          <a:p>
            <a:endParaRPr lang="de-DE"/>
          </a:p>
        </p:txBody>
      </p:sp>
      <p:sp>
        <p:nvSpPr>
          <p:cNvPr id="83" name="Bildplatzhalter 2"/>
          <p:cNvSpPr>
            <a:spLocks noGrp="1"/>
          </p:cNvSpPr>
          <p:nvPr>
            <p:ph type="pic" sz="quarter" idx="12"/>
          </p:nvPr>
        </p:nvSpPr>
        <p:spPr>
          <a:xfrm>
            <a:off x="8123349" y="3626397"/>
            <a:ext cx="4075635" cy="2898229"/>
          </a:xfrm>
          <a:solidFill>
            <a:schemeClr val="bg1">
              <a:lumMod val="85000"/>
            </a:schemeClr>
          </a:solidFill>
        </p:spPr>
        <p:txBody>
          <a:bodyPr/>
          <a:lstStyle/>
          <a:p>
            <a:endParaRPr lang="de-DE"/>
          </a:p>
        </p:txBody>
      </p:sp>
      <p:sp>
        <p:nvSpPr>
          <p:cNvPr id="84" name="Rectangle 9"/>
          <p:cNvSpPr>
            <a:spLocks noChangeArrowheads="1"/>
          </p:cNvSpPr>
          <p:nvPr userDrawn="1"/>
        </p:nvSpPr>
        <p:spPr bwMode="auto">
          <a:xfrm>
            <a:off x="594884" y="1388473"/>
            <a:ext cx="175654" cy="2016000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  <a:effectLst/>
          <a:extLst/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defRPr/>
            </a:pPr>
            <a:endParaRPr lang="de-DE" altLang="de-DE" sz="1757">
              <a:solidFill>
                <a:schemeClr val="accent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815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7009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8852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3511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5254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7234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4109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4497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92F2D-F000-4658-922B-D8408405C616}" type="datetimeFigureOut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A432B-BB13-4E3A-92B4-983D3501AB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3202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2ED65-9CEE-4361-B3CF-D3C311138233}" type="datetime1">
              <a:rPr lang="de-DE" smtClean="0"/>
              <a:t>16.08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D9107-63FB-4AC2-921A-842666C50B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3873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3.jpe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openxmlformats.org/officeDocument/2006/relationships/chart" Target="../charts/chart5.xml"/><Relationship Id="rId7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 #2</a:t>
            </a:r>
            <a:endParaRPr lang="en-US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demographics</a:t>
            </a:r>
            <a:endParaRPr lang="en-US" dirty="0"/>
          </a:p>
        </p:txBody>
      </p:sp>
      <p:pic>
        <p:nvPicPr>
          <p:cNvPr id="4" name="Grafik 3" descr="Ein Bild, das Text enthält.&#10;&#10;Automatisch generierte Beschreibung">
            <a:extLst>
              <a:ext uri="{FF2B5EF4-FFF2-40B4-BE49-F238E27FC236}">
                <a16:creationId xmlns:a16="http://schemas.microsoft.com/office/drawing/2014/main" id="{7D001BDD-2B84-E540-B5FE-4247DA3A241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97702" y="218124"/>
            <a:ext cx="1178335" cy="465999"/>
          </a:xfrm>
          <a:prstGeom prst="rect">
            <a:avLst/>
          </a:prstGeom>
          <a:ln>
            <a:noFill/>
          </a:ln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56380" y="5564221"/>
            <a:ext cx="519657" cy="7591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69337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4294967295"/>
          </p:nvPr>
        </p:nvSpPr>
        <p:spPr>
          <a:xfrm>
            <a:off x="9113108" y="6323399"/>
            <a:ext cx="2743200" cy="365125"/>
          </a:xfrm>
        </p:spPr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39D9107-63FB-4AC2-921A-842666C50BA6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5755409"/>
              </p:ext>
            </p:extLst>
          </p:nvPr>
        </p:nvGraphicFramePr>
        <p:xfrm>
          <a:off x="8035367" y="992221"/>
          <a:ext cx="3073620" cy="5017714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2178213">
                  <a:extLst>
                    <a:ext uri="{9D8B030D-6E8A-4147-A177-3AD203B41FA5}">
                      <a16:colId xmlns:a16="http://schemas.microsoft.com/office/drawing/2014/main" val="4043260417"/>
                    </a:ext>
                  </a:extLst>
                </a:gridCol>
                <a:gridCol w="895407">
                  <a:extLst>
                    <a:ext uri="{9D8B030D-6E8A-4147-A177-3AD203B41FA5}">
                      <a16:colId xmlns:a16="http://schemas.microsoft.com/office/drawing/2014/main" val="3662769016"/>
                    </a:ext>
                  </a:extLst>
                </a:gridCol>
              </a:tblGrid>
              <a:tr h="508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416835679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age (years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41139316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5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57906762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an (SD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2.7 (11.5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801854620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an (range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5 (29-73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227314914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duration of practice  (years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66531213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5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32348865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an (SD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4.6 (11.0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51047912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an (range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6 (2-47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378845992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duration specialized in MS (years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49037764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5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8432141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an (SD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9.1 (9.6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97464767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an (range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9 (0-37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286146569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place of practice, n (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529149714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city (&gt; 100.000 residents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40 (72.2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411002838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town, rural area  (&lt;= 100.000 residents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4 (25.5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67113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ot specified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 (1.8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30395437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type of practice, n (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87033719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licensed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1 (20.0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414732563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self-employed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180975" indent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0 (18.2%)</a:t>
                      </a:r>
                      <a:endParaRPr lang="de-DE" sz="1050" b="0" i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207032514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cal care center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 (1.8%)</a:t>
                      </a:r>
                      <a:endParaRPr lang="de-DE" sz="1050" b="0" i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80931588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clinic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42 (76.4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029619591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outpatient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5 (27.3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616694652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inpatient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1 (38.2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87686229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out- and inpatient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6 (10.9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20882574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retirement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 (3.6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87077217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country, n (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75842578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Germany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48 (87.3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53995907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Austria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 (3.6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64562292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Switzerland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 (9.1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6397878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159972162"/>
                  </a:ext>
                </a:extLst>
              </a:tr>
            </a:tbl>
          </a:graphicData>
        </a:graphic>
      </p:graphicFrame>
      <p:graphicFrame>
        <p:nvGraphicFramePr>
          <p:cNvPr id="7" name="Diagramm 6"/>
          <p:cNvGraphicFramePr>
            <a:graphicFrameLocks/>
          </p:cNvGraphicFramePr>
          <p:nvPr>
            <p:extLst/>
          </p:nvPr>
        </p:nvGraphicFramePr>
        <p:xfrm>
          <a:off x="4225972" y="3992444"/>
          <a:ext cx="3591537" cy="2857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Diagram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4803502"/>
              </p:ext>
            </p:extLst>
          </p:nvPr>
        </p:nvGraphicFramePr>
        <p:xfrm>
          <a:off x="435300" y="4029856"/>
          <a:ext cx="3848932" cy="2787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Diagramm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6219290"/>
              </p:ext>
            </p:extLst>
          </p:nvPr>
        </p:nvGraphicFramePr>
        <p:xfrm>
          <a:off x="719846" y="879308"/>
          <a:ext cx="3782244" cy="2856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435300" y="268538"/>
            <a:ext cx="49840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800" b="0" i="0" u="none" strike="noStrike" kern="1200" cap="none" spc="0" normalizeH="0" baseline="0" dirty="0" smtClean="0">
                <a:ln>
                  <a:noFill/>
                </a:ln>
                <a:solidFill>
                  <a:srgbClr val="5B9BD5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mographic data round 1, n=55</a:t>
            </a:r>
            <a:endParaRPr kumimoji="0" lang="en-US" sz="2800" b="0" i="0" u="none" strike="noStrike" kern="1200" cap="none" spc="0" normalizeH="0" baseline="0" dirty="0">
              <a:ln>
                <a:noFill/>
              </a:ln>
              <a:solidFill>
                <a:srgbClr val="5B9BD5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1" name="Diagram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3552149"/>
              </p:ext>
            </p:extLst>
          </p:nvPr>
        </p:nvGraphicFramePr>
        <p:xfrm>
          <a:off x="4719948" y="879308"/>
          <a:ext cx="2962643" cy="2517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13" name="Grafik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56380" y="5564221"/>
            <a:ext cx="519657" cy="759178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4404" y="154916"/>
            <a:ext cx="1321633" cy="523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5481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4294967295"/>
          </p:nvPr>
        </p:nvSpPr>
        <p:spPr>
          <a:xfrm>
            <a:off x="9113108" y="6323399"/>
            <a:ext cx="2743200" cy="365125"/>
          </a:xfrm>
        </p:spPr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39D9107-63FB-4AC2-921A-842666C50BA6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2998763"/>
              </p:ext>
            </p:extLst>
          </p:nvPr>
        </p:nvGraphicFramePr>
        <p:xfrm>
          <a:off x="8035367" y="992221"/>
          <a:ext cx="3073620" cy="5017714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2178213">
                  <a:extLst>
                    <a:ext uri="{9D8B030D-6E8A-4147-A177-3AD203B41FA5}">
                      <a16:colId xmlns:a16="http://schemas.microsoft.com/office/drawing/2014/main" val="4043260417"/>
                    </a:ext>
                  </a:extLst>
                </a:gridCol>
                <a:gridCol w="895407">
                  <a:extLst>
                    <a:ext uri="{9D8B030D-6E8A-4147-A177-3AD203B41FA5}">
                      <a16:colId xmlns:a16="http://schemas.microsoft.com/office/drawing/2014/main" val="3662769016"/>
                    </a:ext>
                  </a:extLst>
                </a:gridCol>
              </a:tblGrid>
              <a:tr h="508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416835679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age (years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41139316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9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57906762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an (SD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3.1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0.7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801854620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an (range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56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29-73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227314914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duration of practice  (years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66531213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de-DE" sz="90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32348865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an (SD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6.3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1.2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51047912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an (range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8 (3-52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378845992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duration specialized in MS (years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49037764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de-DE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7</a:t>
                      </a:r>
                      <a:endParaRPr lang="de-DE" sz="90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8432141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an (SD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9.2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9.4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97464767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an (range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8 (1-37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286146569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place of practice, n (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529149714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city (&gt; 100.000 residents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39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79.6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411002838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town, rural area  (&lt;= 100.000 residents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2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4.5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67113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not specified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4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 (8.2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30395437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type of practice, n (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87033719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licensed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0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0.4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414732563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self-employed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180975" indent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9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8.4%)</a:t>
                      </a:r>
                      <a:endParaRPr lang="de-DE" sz="1050" b="0" i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207032514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medical care center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 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2.0%)</a:t>
                      </a:r>
                      <a:endParaRPr lang="de-DE" sz="1050" b="0" i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80931588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clinic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39 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76.4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029619591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outpatient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5 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(30.6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616694652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inpatient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0 (40.8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876862293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37401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out- and inpatient</a:t>
                      </a:r>
                      <a:endParaRPr lang="de-DE" sz="1050" b="0" i="1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 marL="0" indent="18097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4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 (8.2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320882574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retirement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2 (3.6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870772177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country, n (%)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 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275842578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Germany</a:t>
                      </a: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47 (95.9.3</a:t>
                      </a: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53995907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Austria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 (2.0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645622928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Switzerland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1</a:t>
                      </a:r>
                      <a:r>
                        <a:rPr lang="en-US" sz="900" b="0" dirty="0" smtClean="0">
                          <a:solidFill>
                            <a:schemeClr val="accent1">
                              <a:lumMod val="50000"/>
                            </a:schemeClr>
                          </a:solidFill>
                          <a:effectLst/>
                        </a:rPr>
                        <a:t> (2.0%)</a:t>
                      </a: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63978786"/>
                  </a:ext>
                </a:extLst>
              </a:tr>
              <a:tr h="161218">
                <a:tc>
                  <a:txBody>
                    <a:bodyPr/>
                    <a:lstStyle/>
                    <a:p>
                      <a:pPr indent="201295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1050" b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de-DE" sz="1050" b="0" dirty="0">
                        <a:solidFill>
                          <a:schemeClr val="accent1">
                            <a:lumMod val="50000"/>
                          </a:schemeClr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47" marR="63547" marT="0" marB="0"/>
                </a:tc>
                <a:extLst>
                  <a:ext uri="{0D108BD9-81ED-4DB2-BD59-A6C34878D82A}">
                    <a16:rowId xmlns:a16="http://schemas.microsoft.com/office/drawing/2014/main" val="1159972162"/>
                  </a:ext>
                </a:extLst>
              </a:tr>
            </a:tbl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435300" y="268538"/>
            <a:ext cx="49840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5B9BD5">
                    <a:lumMod val="75000"/>
                  </a:srgbClr>
                </a:solidFill>
              </a:rPr>
              <a:t>Demographic data </a:t>
            </a:r>
            <a:r>
              <a:rPr lang="en-US" sz="2800" dirty="0" smtClean="0">
                <a:solidFill>
                  <a:srgbClr val="5B9BD5">
                    <a:lumMod val="75000"/>
                  </a:srgbClr>
                </a:solidFill>
              </a:rPr>
              <a:t>round 2, </a:t>
            </a:r>
            <a:r>
              <a:rPr kumimoji="0" lang="de-DE" sz="2800" b="0" i="0" u="none" strike="noStrike" kern="1200" cap="none" spc="0" normalizeH="0" baseline="0" noProof="0" dirty="0" smtClean="0">
                <a:ln>
                  <a:noFill/>
                </a:ln>
                <a:solidFill>
                  <a:srgbClr val="5B9BD5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=49</a:t>
            </a:r>
            <a:endParaRPr kumimoji="0" lang="de-DE" sz="2800" b="0" i="0" u="none" strike="noStrike" kern="1200" cap="none" spc="0" normalizeH="0" baseline="0" noProof="0" dirty="0">
              <a:ln>
                <a:noFill/>
              </a:ln>
              <a:solidFill>
                <a:srgbClr val="5B9BD5">
                  <a:lumMod val="75000"/>
                </a:srgb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3" name="Diagramm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9667696"/>
              </p:ext>
            </p:extLst>
          </p:nvPr>
        </p:nvGraphicFramePr>
        <p:xfrm>
          <a:off x="542392" y="879308"/>
          <a:ext cx="4334408" cy="30061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Diagramm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1253645"/>
              </p:ext>
            </p:extLst>
          </p:nvPr>
        </p:nvGraphicFramePr>
        <p:xfrm>
          <a:off x="4171160" y="3972985"/>
          <a:ext cx="3941741" cy="27155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Diagramm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8041778"/>
              </p:ext>
            </p:extLst>
          </p:nvPr>
        </p:nvGraphicFramePr>
        <p:xfrm>
          <a:off x="542392" y="3972985"/>
          <a:ext cx="3628768" cy="2555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Diagramm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6728770"/>
              </p:ext>
            </p:extLst>
          </p:nvPr>
        </p:nvGraphicFramePr>
        <p:xfrm>
          <a:off x="4876800" y="879308"/>
          <a:ext cx="2946255" cy="24319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11" name="Grafik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56380" y="5564221"/>
            <a:ext cx="519657" cy="759178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4404" y="154916"/>
            <a:ext cx="1321633" cy="523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98156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Benutzerdefiniertes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1</Words>
  <Application>Microsoft Office PowerPoint</Application>
  <PresentationFormat>Breitbild</PresentationFormat>
  <Paragraphs>133</Paragraphs>
  <Slides>3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2</vt:i4>
      </vt:variant>
      <vt:variant>
        <vt:lpstr>Folientitel</vt:lpstr>
      </vt:variant>
      <vt:variant>
        <vt:i4>3</vt:i4>
      </vt:variant>
    </vt:vector>
  </HeadingPairs>
  <TitlesOfParts>
    <vt:vector size="10" baseType="lpstr">
      <vt:lpstr>Arial</vt:lpstr>
      <vt:lpstr>Arial Black</vt:lpstr>
      <vt:lpstr>Calibri</vt:lpstr>
      <vt:lpstr>Calibri Light</vt:lpstr>
      <vt:lpstr>Times New Roman</vt:lpstr>
      <vt:lpstr>Office</vt:lpstr>
      <vt:lpstr>Benutzerdefiniertes Design</vt:lpstr>
      <vt:lpstr>Supplement #2</vt:lpstr>
      <vt:lpstr>PowerPoint-Präsentation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 #2</dc:title>
  <dc:creator>Voigt, Isabel</dc:creator>
  <cp:lastModifiedBy>Voigt, Isabel</cp:lastModifiedBy>
  <cp:revision>10</cp:revision>
  <dcterms:created xsi:type="dcterms:W3CDTF">2023-08-15T09:45:28Z</dcterms:created>
  <dcterms:modified xsi:type="dcterms:W3CDTF">2023-08-16T08:17:49Z</dcterms:modified>
</cp:coreProperties>
</file>